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78" r:id="rId27"/>
    <p:sldId id="279" r:id="rId28"/>
    <p:sldId id="280" r:id="rId29"/>
    <p:sldId id="281" r:id="rId30"/>
    <p:sldId id="282" r:id="rId31"/>
    <p:sldId id="283" r:id="rId32"/>
    <p:sldId id="284" r:id="rId33"/>
    <p:sldId id="285" r:id="rId34"/>
    <p:sldId id="286" r:id="rId35"/>
    <p:sldId id="287" r:id="rId36"/>
    <p:sldId id="288" r:id="rId37"/>
    <p:sldId id="289" r:id="rId38"/>
    <p:sldId id="290" r:id="rId39"/>
    <p:sldId id="291" r:id="rId40"/>
    <p:sldId id="292" r:id="rId41"/>
    <p:sldId id="293" r:id="rId42"/>
    <p:sldId id="294" r:id="rId43"/>
    <p:sldId id="295" r:id="rId44"/>
    <p:sldId id="296" r:id="rId45"/>
    <p:sldId id="297" r:id="rId46"/>
    <p:sldId id="298" r:id="rId47"/>
    <p:sldId id="299" r:id="rId48"/>
    <p:sldId id="300" r:id="rId49"/>
    <p:sldId id="301" r:id="rId50"/>
    <p:sldId id="302" r:id="rId51"/>
    <p:sldId id="303" r:id="rId52"/>
    <p:sldId id="304" r:id="rId53"/>
    <p:sldId id="305" r:id="rId54"/>
    <p:sldId id="306" r:id="rId5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087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3282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slide" Target="slides/slide38.xml"/><Relationship Id="rId47" Type="http://schemas.openxmlformats.org/officeDocument/2006/relationships/slide" Target="slides/slide43.xml"/><Relationship Id="rId50" Type="http://schemas.openxmlformats.org/officeDocument/2006/relationships/slide" Target="slides/slide46.xml"/><Relationship Id="rId55" Type="http://schemas.openxmlformats.org/officeDocument/2006/relationships/slide" Target="slides/slide5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slide" Target="slides/slide42.xml"/><Relationship Id="rId59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41" Type="http://schemas.openxmlformats.org/officeDocument/2006/relationships/slide" Target="slides/slide37.xml"/><Relationship Id="rId54" Type="http://schemas.openxmlformats.org/officeDocument/2006/relationships/slide" Target="slides/slide50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slide" Target="slides/slide41.xml"/><Relationship Id="rId53" Type="http://schemas.openxmlformats.org/officeDocument/2006/relationships/slide" Target="slides/slide49.xml"/><Relationship Id="rId58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openxmlformats.org/officeDocument/2006/relationships/slide" Target="slides/slide45.xml"/><Relationship Id="rId57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slide" Target="slides/slide40.xml"/><Relationship Id="rId52" Type="http://schemas.openxmlformats.org/officeDocument/2006/relationships/slide" Target="slides/slide48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slide" Target="slides/slide39.xml"/><Relationship Id="rId48" Type="http://schemas.openxmlformats.org/officeDocument/2006/relationships/slide" Target="slides/slide44.xml"/><Relationship Id="rId56" Type="http://schemas.openxmlformats.org/officeDocument/2006/relationships/presProps" Target="presProps.xml"/><Relationship Id="rId8" Type="http://schemas.openxmlformats.org/officeDocument/2006/relationships/slide" Target="slides/slide4.xml"/><Relationship Id="rId51" Type="http://schemas.openxmlformats.org/officeDocument/2006/relationships/slide" Target="slides/slide47.xml"/><Relationship Id="rId3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90EE9-50AD-4311-A360-6D88BD8658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148044-8DE8-4BD3-8DE6-C75C2F5DFE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AA6FD8-B527-42D3-8E7C-72AF00864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E2778D-9C83-41AD-B044-CB2FF257D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4F0E7C-AFCA-4AC4-A63D-CC886E1F0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9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B433A-FE9C-4710-AAC0-CFF1B224D5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F87C21-D7A0-4CCB-826D-18D199CD1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B5128D-4CC8-4969-9313-116C6CC48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21B1B3-1B36-441A-BD60-5E223340D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531D14-490C-4BD8-A6A8-5989FD99F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759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B97A3A9-388D-412C-B78D-DDEAB6BA8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54E6BF-B8C3-4965-B3BF-F2315C4259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170C97-9C88-4371-8C8E-A89A8FE23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00A99-FE8D-44BB-8BF3-D65BE4190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36BE6-7898-4514-ACC1-B2DD3FF04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13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7F934-4EFB-4F1A-B0DF-FEC666EB84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036DBE-D944-422B-A4F5-D493412A03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3ABEEA-F5E3-4AC4-B64D-C5300A5FA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C15DDB-559F-4058-BFD5-2210450A34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B8214-E259-411F-90C5-3D857191A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584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D25DAC-8930-41F5-BDE2-D44CA44AD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EE25FA-8B9C-4F61-94EB-0057651D4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788CA-B067-40FF-9BB1-7CE8388A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D498D8-7767-45AB-9B96-3CACFF12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22675-8B59-4D74-A065-39CCEF7FE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077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200F1-9CDE-4444-BBAE-6D7A4CED2F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6B68E-AD2F-432B-BF06-C695A760D7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EE5EA0-1CAC-4D56-91B2-1BE4128622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D657C4-C980-4D84-9100-2EB78FB72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0F931-BBEF-40FC-90D8-60266E071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9543D-65E6-431F-BCD2-530C47CB6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960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BF01B-E2A4-4EAD-947D-CA88CA109F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709BE3-290D-40F2-92E4-05DCDFAD93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C9C1B9-4042-422B-86B1-954B4B8C40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65E13A-75D0-48C7-A50F-A62300845C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DE310A0-1BCF-4BB1-A3A8-9FA993A889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FFD16-3221-4912-81A4-20989CF86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E439BFD-2F8A-420D-98C2-6E1D1FF75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7AC0A5-39FD-4F59-A02A-AC77F4F80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81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627748-1482-4303-9AF8-E97724B9BE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ABB4A3-2409-4DD8-970A-2D23EDB28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F6DA8D-08D0-4CDB-81AD-4E625AC83F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FFA867-262F-4AA0-B4B4-5D7279A37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7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424663-E24F-4187-86D7-711B85165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EECFC5-4367-4ADC-A209-E5575A9BF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34E3ED-1F02-42C0-AD7F-AC2EBEC71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93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A0065-B281-460A-9116-7BE92688A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60AD1-044B-4146-8A2D-69F0046A9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68F3E3-1AC5-4593-BF1A-237F71792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40CDDF-2C2A-45DD-BEF7-F533CF748E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77004A-44FE-4127-83AD-D52FE07EC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356837-BF82-46D4-9CCB-933756011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6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8B7BB-828B-4116-9A3A-33CDECF6A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FECBAE-AB2B-4041-99DE-66E3AACDC0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6F0C5E-E67B-4B20-9C7C-D54BFAADE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96A703-F743-4935-9CEC-A078A9A7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A02116-0695-4A1F-93F3-3D0336E82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2A82F3-B99C-454F-8B10-0D163F89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961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884E9C-9ABE-4DCA-A5A8-9FE551EFF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0AB5AC-C87A-46ED-AA83-848B8E0AAA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67F78-BCDA-4B04-8E69-588398A5EE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8BB2A-6661-44CC-A200-C6795F7950C2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020622-234B-4650-B137-AD8822ECE9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9CD29F-6AF3-4D79-8621-0731DC7246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FE826-E6FE-48AF-AAF3-7B95426745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761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jp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88738E01-4378-4727-AEC4-AA6CAA8F06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564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arthropod&#10;&#10;Description automatically generated">
            <a:extLst>
              <a:ext uri="{FF2B5EF4-FFF2-40B4-BE49-F238E27FC236}">
                <a16:creationId xmlns:a16="http://schemas.microsoft.com/office/drawing/2014/main" id="{4184F572-E138-4F96-9256-58B2F5D4B7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6504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6C5816F5-D685-41BE-8482-9F700566D6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18935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B3778B8E-2480-4DE2-9248-6DDE0C111E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4888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9E0408F2-6595-4008-9D60-74AA9C8D10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6522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16DD3190-4CD0-4927-BC5C-6C3327CA5E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1495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ri scan of the brain&#10;&#10;Description automatically generated with low confidence">
            <a:extLst>
              <a:ext uri="{FF2B5EF4-FFF2-40B4-BE49-F238E27FC236}">
                <a16:creationId xmlns:a16="http://schemas.microsoft.com/office/drawing/2014/main" id="{CCB81D1C-B720-4076-84E1-1A1F89C8AF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80665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59681E64-0FDD-4C18-BE0E-5C368A4896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89711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BE375321-0839-42FE-97DB-378AA219E4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7512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low confidence">
            <a:extLst>
              <a:ext uri="{FF2B5EF4-FFF2-40B4-BE49-F238E27FC236}">
                <a16:creationId xmlns:a16="http://schemas.microsoft.com/office/drawing/2014/main" id="{081A2DFB-C3CD-427E-97E3-544A702AC8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9715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fruit, citrus&#10;&#10;Description automatically generated">
            <a:extLst>
              <a:ext uri="{FF2B5EF4-FFF2-40B4-BE49-F238E27FC236}">
                <a16:creationId xmlns:a16="http://schemas.microsoft.com/office/drawing/2014/main" id="{327F9514-E9ED-4E0B-8CE7-D4786014F4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2891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8CACC0F5-53CD-496F-A4C4-C644D2FD38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3608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fruit, echinoderm&#10;&#10;Description automatically generated">
            <a:extLst>
              <a:ext uri="{FF2B5EF4-FFF2-40B4-BE49-F238E27FC236}">
                <a16:creationId xmlns:a16="http://schemas.microsoft.com/office/drawing/2014/main" id="{AC68BBB7-12D0-43A8-9ED0-D10A4DDCBF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5140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ri scan of the brain&#10;&#10;Description automatically generated with low confidence">
            <a:extLst>
              <a:ext uri="{FF2B5EF4-FFF2-40B4-BE49-F238E27FC236}">
                <a16:creationId xmlns:a16="http://schemas.microsoft.com/office/drawing/2014/main" id="{34D7B0E3-5BC0-49BA-BBFD-14F663DBE1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4882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ri scan of the brain&#10;&#10;Description automatically generated with low confidence">
            <a:extLst>
              <a:ext uri="{FF2B5EF4-FFF2-40B4-BE49-F238E27FC236}">
                <a16:creationId xmlns:a16="http://schemas.microsoft.com/office/drawing/2014/main" id="{95ED4065-AD3C-4A64-BCA1-974C46368B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4004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invertebrate&#10;&#10;Description automatically generated">
            <a:extLst>
              <a:ext uri="{FF2B5EF4-FFF2-40B4-BE49-F238E27FC236}">
                <a16:creationId xmlns:a16="http://schemas.microsoft.com/office/drawing/2014/main" id="{60BE3FD4-80D1-4EB0-AE91-AF30D506E4B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4324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338910A0-480E-4BE8-B0B0-15BC58CB25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92769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CD8DCB23-B337-427A-A4C8-28ABD2CB0E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625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brain&#10;&#10;Description automatically generated with low confidence">
            <a:extLst>
              <a:ext uri="{FF2B5EF4-FFF2-40B4-BE49-F238E27FC236}">
                <a16:creationId xmlns:a16="http://schemas.microsoft.com/office/drawing/2014/main" id="{B41AC905-BE53-4F74-AAEE-DB2B0D562E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919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he brain&#10;&#10;Description automatically generated with medium confidence">
            <a:extLst>
              <a:ext uri="{FF2B5EF4-FFF2-40B4-BE49-F238E27FC236}">
                <a16:creationId xmlns:a16="http://schemas.microsoft.com/office/drawing/2014/main" id="{D7265EDE-C647-4372-9E08-FBD6CFFB6C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7742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oin&#10;&#10;Description automatically generated with low confidence">
            <a:extLst>
              <a:ext uri="{FF2B5EF4-FFF2-40B4-BE49-F238E27FC236}">
                <a16:creationId xmlns:a16="http://schemas.microsoft.com/office/drawing/2014/main" id="{38A1E0D8-7679-49F1-B30F-F025950D0C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6756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he brain&#10;&#10;Description automatically generated with low confidence">
            <a:extLst>
              <a:ext uri="{FF2B5EF4-FFF2-40B4-BE49-F238E27FC236}">
                <a16:creationId xmlns:a16="http://schemas.microsoft.com/office/drawing/2014/main" id="{19966BD8-69D5-4B50-B4BC-E2EAACDBCCA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18944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56990829-6168-41DD-925F-79FF38DE82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478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the brain&#10;&#10;Description automatically generated with low confidence">
            <a:extLst>
              <a:ext uri="{FF2B5EF4-FFF2-40B4-BE49-F238E27FC236}">
                <a16:creationId xmlns:a16="http://schemas.microsoft.com/office/drawing/2014/main" id="{1C480083-65DD-4198-A32C-EB0FC226A4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3403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51D6EC2E-347F-403E-92DE-A7FE508998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1430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FA46232C-71A4-4DC4-A250-AB0B98F0EC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059424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F42EC006-6F3E-4A0E-A701-DF26FF6A75A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7680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 with medium confidence">
            <a:extLst>
              <a:ext uri="{FF2B5EF4-FFF2-40B4-BE49-F238E27FC236}">
                <a16:creationId xmlns:a16="http://schemas.microsoft.com/office/drawing/2014/main" id="{38B5191B-BA60-47A4-94C5-9B838A233E3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4196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225A703C-D335-47D1-8839-AB692F82631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10720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083F851D-42A5-4646-8B2C-9526873B33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9348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36580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91261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719090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human skull&#10;&#10;Description automatically generated with low confidence">
            <a:extLst>
              <a:ext uri="{FF2B5EF4-FFF2-40B4-BE49-F238E27FC236}">
                <a16:creationId xmlns:a16="http://schemas.microsoft.com/office/drawing/2014/main" id="{9BC2424A-35D5-4256-9AB8-0F30751789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66480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933647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657295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2330625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739184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92113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785965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211470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282307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3751672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486366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brain&#10;&#10;Description automatically generated with low confidence">
            <a:extLst>
              <a:ext uri="{FF2B5EF4-FFF2-40B4-BE49-F238E27FC236}">
                <a16:creationId xmlns:a16="http://schemas.microsoft.com/office/drawing/2014/main" id="{7C504AB3-9467-4E2C-9354-456054D5C4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6898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57606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578268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ext&#10;&#10;Description automatically generated">
            <a:extLst>
              <a:ext uri="{FF2B5EF4-FFF2-40B4-BE49-F238E27FC236}">
                <a16:creationId xmlns:a16="http://schemas.microsoft.com/office/drawing/2014/main" id="{C4701347-819C-49EE-934B-20783BA8AB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45084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45F5C850-6B65-431C-9B2B-12A21D8B25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3613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&#10;&#10;Description automatically generated">
            <a:extLst>
              <a:ext uri="{FF2B5EF4-FFF2-40B4-BE49-F238E27FC236}">
                <a16:creationId xmlns:a16="http://schemas.microsoft.com/office/drawing/2014/main" id="{F80DCCFB-4DC8-43F1-8833-6FB86852B3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77989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ook, black&#10;&#10;Description automatically generated">
            <a:extLst>
              <a:ext uri="{FF2B5EF4-FFF2-40B4-BE49-F238E27FC236}">
                <a16:creationId xmlns:a16="http://schemas.microsoft.com/office/drawing/2014/main" id="{5C5D4655-429E-4DC4-AF0B-7924A8A150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7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63877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ACC25D49F2F4B4489B9721A466FDF4D" ma:contentTypeVersion="8" ma:contentTypeDescription="Create a new document." ma:contentTypeScope="" ma:versionID="71e9c98e0f852595cf47c6f661845709">
  <xsd:schema xmlns:xsd="http://www.w3.org/2001/XMLSchema" xmlns:xs="http://www.w3.org/2001/XMLSchema" xmlns:p="http://schemas.microsoft.com/office/2006/metadata/properties" xmlns:ns2="8fddeaa3-4732-4488-9db6-a053d8348361" xmlns:ns3="1e1c5aca-6f1d-4e22-8716-d44e9b47b6c2" targetNamespace="http://schemas.microsoft.com/office/2006/metadata/properties" ma:root="true" ma:fieldsID="9e6f634192e81de9c62830f3e2e111b9" ns2:_="" ns3:_="">
    <xsd:import namespace="8fddeaa3-4732-4488-9db6-a053d8348361"/>
    <xsd:import namespace="1e1c5aca-6f1d-4e22-8716-d44e9b47b6c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fddeaa3-4732-4488-9db6-a053d834836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1c5aca-6f1d-4e22-8716-d44e9b47b6c2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2993ECF-7BF1-469B-A139-E72CFA34A840}">
  <ds:schemaRefs>
    <ds:schemaRef ds:uri="http://purl.org/dc/dcmitype/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http://schemas.microsoft.com/office/2006/metadata/properties"/>
    <ds:schemaRef ds:uri="1e1c5aca-6f1d-4e22-8716-d44e9b47b6c2"/>
    <ds:schemaRef ds:uri="8fddeaa3-4732-4488-9db6-a053d8348361"/>
    <ds:schemaRef ds:uri="http://purl.org/dc/terms/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6DA6FD8D-03D3-439F-8F35-DD170733570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E8BFF279-90E5-44EE-BC01-1C6995A3A68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fddeaa3-4732-4488-9db6-a053d8348361"/>
    <ds:schemaRef ds:uri="1e1c5aca-6f1d-4e22-8716-d44e9b47b6c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0</Words>
  <PresentationFormat>Widescreen</PresentationFormat>
  <Paragraphs>0</Paragraphs>
  <Slides>5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1</vt:i4>
      </vt:variant>
    </vt:vector>
  </HeadingPairs>
  <TitlesOfParts>
    <vt:vector size="5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9-05T17:17:40Z</dcterms:created>
  <dcterms:modified xsi:type="dcterms:W3CDTF">2021-09-07T14:1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ACC25D49F2F4B4489B9721A466FDF4D</vt:lpwstr>
  </property>
</Properties>
</file>